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39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1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5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398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791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10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649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744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531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90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6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49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2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-23408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l </a:t>
            </a:r>
            <a:r>
              <a:rPr lang="en-US" b="1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r>
              <a:rPr lang="en-US" b="1" smtClean="0">
                <a:latin typeface="Helvetica" panose="020B0604020202020204" pitchFamily="34" charset="0"/>
                <a:cs typeface="Helvetica" panose="020B0604020202020204" pitchFamily="34" charset="0"/>
              </a:rPr>
              <a:t>. 2 </a:t>
            </a:r>
            <a:endParaRPr 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5" name="Picture 2" descr="I:\Grad Students\kriti\2015_01_19\IMG_0001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GlowDiffused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055" t="20084" r="23980" b="71153"/>
          <a:stretch/>
        </p:blipFill>
        <p:spPr bwMode="auto">
          <a:xfrm>
            <a:off x="1290319" y="2362799"/>
            <a:ext cx="3948677" cy="12731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608983" y="1684370"/>
            <a:ext cx="736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EHD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514600" y="1676400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NPF-to-NAF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917211" y="1684370"/>
            <a:ext cx="1298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NPF-to-APA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90323" y="2035735"/>
            <a:ext cx="573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nput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47978" y="2035735"/>
            <a:ext cx="430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.P.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621340" y="2035735"/>
            <a:ext cx="573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nput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33838" y="2035735"/>
            <a:ext cx="430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.P.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98298" y="2035735"/>
            <a:ext cx="573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nput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016545" y="2035735"/>
            <a:ext cx="430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.P.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1289899" y="2020480"/>
            <a:ext cx="3942225" cy="33735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1290157" y="1683393"/>
            <a:ext cx="3942225" cy="33735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8" name="Straight Connector 27"/>
          <p:cNvCxnSpPr/>
          <p:nvPr/>
        </p:nvCxnSpPr>
        <p:spPr>
          <a:xfrm>
            <a:off x="674714" y="2020480"/>
            <a:ext cx="674721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674241" y="168437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Helvetica"/>
                <a:cs typeface="Helvetica"/>
              </a:rPr>
              <a:t>wt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>
            <a:off x="2493813" y="1683130"/>
            <a:ext cx="0" cy="67470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3817051" y="1683391"/>
            <a:ext cx="0" cy="67470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2" name="Group 41"/>
          <p:cNvGrpSpPr/>
          <p:nvPr/>
        </p:nvGrpSpPr>
        <p:grpSpPr>
          <a:xfrm>
            <a:off x="706677" y="2549656"/>
            <a:ext cx="588723" cy="972066"/>
            <a:chOff x="0" y="2549656"/>
            <a:chExt cx="588723" cy="972066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383661" y="2695179"/>
              <a:ext cx="205062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383661" y="2953414"/>
              <a:ext cx="205062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83661" y="3423319"/>
              <a:ext cx="205062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0" y="2549656"/>
              <a:ext cx="4414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100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5585" y="279466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75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85585" y="324472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50</a:t>
              </a:r>
              <a:endParaRPr lang="en-US" sz="1200" dirty="0">
                <a:latin typeface="Helvetica"/>
                <a:cs typeface="Helvetica"/>
              </a:endParaRPr>
            </a:p>
          </p:txBody>
        </p:sp>
      </p:grpSp>
      <p:sp>
        <p:nvSpPr>
          <p:cNvPr id="71" name="Rectangle 70"/>
          <p:cNvSpPr/>
          <p:nvPr/>
        </p:nvSpPr>
        <p:spPr>
          <a:xfrm>
            <a:off x="1295399" y="2356238"/>
            <a:ext cx="3943669" cy="1270029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3" name="Group 72"/>
          <p:cNvGrpSpPr/>
          <p:nvPr/>
        </p:nvGrpSpPr>
        <p:grpSpPr>
          <a:xfrm>
            <a:off x="1687225" y="4970566"/>
            <a:ext cx="3553840" cy="1844747"/>
            <a:chOff x="1687225" y="3636792"/>
            <a:chExt cx="3553840" cy="1844747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/>
            <a:srcRect l="16377" t="23416" r="13412" b="50873"/>
            <a:stretch/>
          </p:blipFill>
          <p:spPr>
            <a:xfrm>
              <a:off x="2374743" y="4313230"/>
              <a:ext cx="2866032" cy="1168309"/>
            </a:xfrm>
            <a:prstGeom prst="rect">
              <a:avLst/>
            </a:prstGeom>
          </p:spPr>
        </p:pic>
        <p:grpSp>
          <p:nvGrpSpPr>
            <p:cNvPr id="43" name="Group 42"/>
            <p:cNvGrpSpPr/>
            <p:nvPr/>
          </p:nvGrpSpPr>
          <p:grpSpPr>
            <a:xfrm>
              <a:off x="1766695" y="4438525"/>
              <a:ext cx="588723" cy="972066"/>
              <a:chOff x="0" y="2549656"/>
              <a:chExt cx="588723" cy="972066"/>
            </a:xfrm>
          </p:grpSpPr>
          <p:cxnSp>
            <p:nvCxnSpPr>
              <p:cNvPr id="44" name="Straight Connector 43"/>
              <p:cNvCxnSpPr/>
              <p:nvPr/>
            </p:nvCxnSpPr>
            <p:spPr>
              <a:xfrm>
                <a:off x="383661" y="2695179"/>
                <a:ext cx="205062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383661" y="2953414"/>
                <a:ext cx="205062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383661" y="3423319"/>
                <a:ext cx="205062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0" y="2549656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100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85585" y="2794661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75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85585" y="3244723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50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50" name="TextBox 49"/>
            <p:cNvSpPr txBox="1"/>
            <p:nvPr/>
          </p:nvSpPr>
          <p:spPr>
            <a:xfrm>
              <a:off x="1687225" y="3638032"/>
              <a:ext cx="8035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Helvetica"/>
                  <a:cs typeface="Helvetica"/>
                </a:rPr>
                <a:t>EHD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886200" y="3638032"/>
              <a:ext cx="12869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Helvetica"/>
                  <a:cs typeface="Helvetica"/>
                </a:rPr>
                <a:t>KPF-to-AP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482244" y="3989397"/>
              <a:ext cx="6265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input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728419" y="3989397"/>
              <a:ext cx="4703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I.P.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935207" y="3989397"/>
              <a:ext cx="6265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input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238401" y="3989397"/>
              <a:ext cx="4703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I.P.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2380439" y="3974142"/>
              <a:ext cx="2853101" cy="3373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2380439" y="3637055"/>
              <a:ext cx="2853101" cy="3373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2" name="Straight Connector 61"/>
            <p:cNvCxnSpPr/>
            <p:nvPr/>
          </p:nvCxnSpPr>
          <p:spPr>
            <a:xfrm>
              <a:off x="1810233" y="3974142"/>
              <a:ext cx="736538" cy="0"/>
            </a:xfrm>
            <a:prstGeom prst="line">
              <a:avLst/>
            </a:prstGeom>
            <a:ln w="952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2514600" y="3638032"/>
              <a:ext cx="12905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Helvetica"/>
                  <a:cs typeface="Helvetica"/>
                </a:rPr>
                <a:t>KPF-to-KAF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3795997" y="3636792"/>
              <a:ext cx="0" cy="67470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Rectangle 71"/>
            <p:cNvSpPr/>
            <p:nvPr/>
          </p:nvSpPr>
          <p:spPr>
            <a:xfrm>
              <a:off x="2381394" y="4305061"/>
              <a:ext cx="2859671" cy="117611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75" name="Straight Connector 74"/>
          <p:cNvCxnSpPr/>
          <p:nvPr/>
        </p:nvCxnSpPr>
        <p:spPr>
          <a:xfrm>
            <a:off x="5296320" y="2686935"/>
            <a:ext cx="397440" cy="8639"/>
          </a:xfrm>
          <a:prstGeom prst="line">
            <a:avLst/>
          </a:prstGeom>
          <a:ln>
            <a:solidFill>
              <a:srgbClr val="000000"/>
            </a:solidFill>
            <a:headEnd type="stealth" w="lg" len="lg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5664701" y="2502024"/>
            <a:ext cx="736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EHD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295400" y="1143000"/>
            <a:ext cx="16552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.P:   </a:t>
            </a:r>
            <a:r>
              <a:rPr lang="en-US" sz="1400" dirty="0" smtClean="0">
                <a:latin typeface="Symbol" charset="2"/>
                <a:cs typeface="Symbol" charset="2"/>
              </a:rPr>
              <a:t>a-</a:t>
            </a:r>
            <a:r>
              <a:rPr lang="en-US" sz="1400" dirty="0" smtClean="0">
                <a:latin typeface="Helvetica"/>
                <a:cs typeface="Helvetica"/>
              </a:rPr>
              <a:t>Syndapin2</a:t>
            </a:r>
          </a:p>
          <a:p>
            <a:r>
              <a:rPr lang="en-US" sz="1400" dirty="0" err="1" smtClean="0">
                <a:latin typeface="Helvetica"/>
                <a:cs typeface="Helvetica"/>
              </a:rPr>
              <a:t>w.b</a:t>
            </a:r>
            <a:r>
              <a:rPr lang="en-US" sz="1400" dirty="0" smtClean="0">
                <a:latin typeface="Helvetica"/>
                <a:cs typeface="Helvetica"/>
              </a:rPr>
              <a:t>:   </a:t>
            </a:r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Helvetica"/>
                <a:cs typeface="Helvetica"/>
              </a:rPr>
              <a:t>-EHD2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362200" y="4495800"/>
            <a:ext cx="16552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.P:   </a:t>
            </a:r>
            <a:r>
              <a:rPr lang="en-US" sz="1400" dirty="0" smtClean="0">
                <a:latin typeface="Symbol" charset="2"/>
                <a:cs typeface="Symbol" charset="2"/>
              </a:rPr>
              <a:t>a-</a:t>
            </a:r>
            <a:r>
              <a:rPr lang="en-US" sz="1400" dirty="0" smtClean="0">
                <a:latin typeface="Helvetica"/>
                <a:cs typeface="Helvetica"/>
              </a:rPr>
              <a:t>Syndapin2</a:t>
            </a:r>
          </a:p>
          <a:p>
            <a:r>
              <a:rPr lang="en-US" sz="1400" dirty="0" err="1" smtClean="0">
                <a:latin typeface="Helvetica"/>
                <a:cs typeface="Helvetica"/>
              </a:rPr>
              <a:t>w.b</a:t>
            </a:r>
            <a:r>
              <a:rPr lang="en-US" sz="1400" dirty="0" smtClean="0">
                <a:latin typeface="Helvetica"/>
                <a:cs typeface="Helvetica"/>
              </a:rPr>
              <a:t>:   </a:t>
            </a:r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Helvetica"/>
                <a:cs typeface="Helvetica"/>
              </a:rPr>
              <a:t>-EHD2</a:t>
            </a:r>
            <a:endParaRPr lang="en-US" sz="1400" dirty="0">
              <a:latin typeface="Helvetica"/>
              <a:cs typeface="Helvetica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5250497" y="3461511"/>
            <a:ext cx="397440" cy="8639"/>
          </a:xfrm>
          <a:prstGeom prst="line">
            <a:avLst/>
          </a:prstGeom>
          <a:ln>
            <a:solidFill>
              <a:srgbClr val="000000"/>
            </a:solidFill>
            <a:headEnd type="stealth" w="lg" len="lg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5664013" y="3276600"/>
            <a:ext cx="3557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Helvetica"/>
                <a:cs typeface="Helvetica"/>
              </a:rPr>
              <a:t>Ig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5270419" y="5976111"/>
            <a:ext cx="397440" cy="8639"/>
          </a:xfrm>
          <a:prstGeom prst="line">
            <a:avLst/>
          </a:prstGeom>
          <a:ln>
            <a:solidFill>
              <a:srgbClr val="000000"/>
            </a:solidFill>
            <a:headEnd type="stealth" w="lg" len="lg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5638800" y="5791200"/>
            <a:ext cx="736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EHD2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5224596" y="6750687"/>
            <a:ext cx="397440" cy="8639"/>
          </a:xfrm>
          <a:prstGeom prst="line">
            <a:avLst/>
          </a:prstGeom>
          <a:ln>
            <a:solidFill>
              <a:srgbClr val="000000"/>
            </a:solidFill>
            <a:headEnd type="stealth" w="lg" len="lg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5638112" y="6565776"/>
            <a:ext cx="3557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Helvetica"/>
                <a:cs typeface="Helvetica"/>
              </a:rPr>
              <a:t>Ig</a:t>
            </a:r>
            <a:endParaRPr lang="en-US" sz="16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64887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Macintosh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Caplan</dc:creator>
  <cp:lastModifiedBy>Steve Caplan</cp:lastModifiedBy>
  <cp:revision>1</cp:revision>
  <dcterms:created xsi:type="dcterms:W3CDTF">2015-01-19T19:54:23Z</dcterms:created>
  <dcterms:modified xsi:type="dcterms:W3CDTF">2015-01-19T19:55:16Z</dcterms:modified>
</cp:coreProperties>
</file>